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61" r:id="rId5"/>
  </p:sldIdLst>
  <p:sldSz cx="68580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8CDC4FA-0646-F260-29E5-CB445F230EF4}" name="Heese, Antje" initials="HA" userId="S::heesea@umsystem.edu::5f7e3c74-0ce5-441c-a81e-acc659041d1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DE00"/>
    <a:srgbClr val="FF9900"/>
    <a:srgbClr val="FFCC00"/>
    <a:srgbClr val="9900CC"/>
    <a:srgbClr val="DA0058"/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BA36708-7361-47DE-8C63-0DE36447D34C}" v="1" dt="2022-10-11T19:04:51.8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72" autoAdjust="0"/>
    <p:restoredTop sz="94660"/>
  </p:normalViewPr>
  <p:slideViewPr>
    <p:cSldViewPr snapToGrid="0">
      <p:cViewPr varScale="1">
        <p:scale>
          <a:sx n="56" d="100"/>
          <a:sy n="56" d="100"/>
        </p:scale>
        <p:origin x="230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46133"/>
            <a:ext cx="5829300" cy="350181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82989"/>
            <a:ext cx="5143500" cy="242845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80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20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35517"/>
            <a:ext cx="1478756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35517"/>
            <a:ext cx="4350544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984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881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507618"/>
            <a:ext cx="5915025" cy="418401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731215"/>
            <a:ext cx="5915025" cy="22002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44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77584"/>
            <a:ext cx="291465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77584"/>
            <a:ext cx="291465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66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5519"/>
            <a:ext cx="591502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65706"/>
            <a:ext cx="2901255" cy="12084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74110"/>
            <a:ext cx="2901255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65706"/>
            <a:ext cx="2915543" cy="12084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74110"/>
            <a:ext cx="291554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411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680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487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560"/>
            <a:ext cx="2211884" cy="23469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48226"/>
            <a:ext cx="3471863" cy="714798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17520"/>
            <a:ext cx="2211884" cy="559032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29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560"/>
            <a:ext cx="2211884" cy="23469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48226"/>
            <a:ext cx="3471863" cy="714798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17520"/>
            <a:ext cx="2211884" cy="559032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052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35519"/>
            <a:ext cx="591502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77584"/>
            <a:ext cx="591502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322649"/>
            <a:ext cx="154305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8BFB3-1F27-4BAF-8DF2-288D2A7F3536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322649"/>
            <a:ext cx="231457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322649"/>
            <a:ext cx="154305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DF273-4D32-4433-AC6C-5DA67AAE0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989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5" Type="http://schemas.openxmlformats.org/officeDocument/2006/relationships/hyperlink" Target="https://pymol.org/2/" TargetMode="Externa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EPS1 - alphafold with MTV1 - with labels - slow version">
            <a:hlinkClick r:id="" action="ppaction://media"/>
            <a:extLst>
              <a:ext uri="{FF2B5EF4-FFF2-40B4-BE49-F238E27FC236}">
                <a16:creationId xmlns:a16="http://schemas.microsoft.com/office/drawing/2014/main" id="{6EC0AD41-5475-43A2-94E9-E363A8150A8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873332"/>
            <a:ext cx="6858000" cy="328136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EDB9449-F726-47B6-9022-F79D1D2C2FBE}"/>
              </a:ext>
            </a:extLst>
          </p:cNvPr>
          <p:cNvSpPr txBox="1"/>
          <p:nvPr/>
        </p:nvSpPr>
        <p:spPr>
          <a:xfrm>
            <a:off x="687220" y="3964716"/>
            <a:ext cx="5651106" cy="12003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Supplemental Movie S1. Rotation of EPS1 and MTV1 ENTH-domain structures</a:t>
            </a:r>
            <a:r>
              <a:rPr lang="en-US" sz="1200" b="1" i="1" dirty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Predicted</a:t>
            </a:r>
            <a:r>
              <a:rPr lang="en-US" sz="1200" b="1" i="1" dirty="0">
                <a:latin typeface="Times New Roman"/>
                <a:cs typeface="Times New Roman"/>
              </a:rPr>
              <a:t> </a:t>
            </a:r>
            <a:r>
              <a:rPr lang="en-US" sz="1200" i="1" dirty="0">
                <a:latin typeface="Times New Roman"/>
                <a:cs typeface="Times New Roman"/>
              </a:rPr>
              <a:t>At</a:t>
            </a:r>
            <a:r>
              <a:rPr lang="en-US" sz="1200" dirty="0">
                <a:latin typeface="Times New Roman"/>
                <a:cs typeface="Times New Roman"/>
              </a:rPr>
              <a:t>EPS1 ENTH-domain (green) was received from </a:t>
            </a:r>
            <a:r>
              <a:rPr lang="en-US" sz="1200" dirty="0" err="1">
                <a:latin typeface="Times New Roman"/>
                <a:cs typeface="Times New Roman"/>
              </a:rPr>
              <a:t>Alphafold</a:t>
            </a:r>
            <a:r>
              <a:rPr lang="en-US" sz="1200" dirty="0">
                <a:latin typeface="Times New Roman"/>
                <a:cs typeface="Times New Roman"/>
              </a:rPr>
              <a:t> (AF-Q8VY07-F1-model_v2) (amino acids 27-152). Previously published NMR structure of </a:t>
            </a:r>
            <a:r>
              <a:rPr lang="en-US" sz="1200" i="1" dirty="0">
                <a:latin typeface="Times New Roman"/>
                <a:cs typeface="Times New Roman"/>
              </a:rPr>
              <a:t>At</a:t>
            </a:r>
            <a:r>
              <a:rPr lang="en-US" sz="1200" dirty="0">
                <a:latin typeface="Times New Roman"/>
                <a:cs typeface="Times New Roman"/>
              </a:rPr>
              <a:t>MTV1 ENTH-domain (cyan) was received from PDB (2DCP) (amino acids 9-135; ref 13). Structures were aligned and visualized using PYMOL (</a:t>
            </a:r>
            <a:r>
              <a:rPr lang="en-US" sz="1200" dirty="0">
                <a:latin typeface="Times New Roman"/>
                <a:ea typeface="+mn-lt"/>
                <a:cs typeface="+mn-lt"/>
                <a:hlinkClick r:id="rId5"/>
              </a:rPr>
              <a:t>https://pymol.org/2/</a:t>
            </a:r>
            <a:r>
              <a:rPr lang="en-US" sz="1200" dirty="0">
                <a:latin typeface="Times New Roman"/>
                <a:ea typeface="+mn-lt"/>
                <a:cs typeface="+mn-lt"/>
              </a:rPr>
              <a:t>)</a:t>
            </a:r>
            <a:r>
              <a:rPr lang="en-US" sz="1200" dirty="0">
                <a:latin typeface="Times New Roman"/>
                <a:cs typeface="Times New Roman"/>
              </a:rPr>
              <a:t>. N- and C-termini of both ENTH-domains are labeled as N and C, respectively. 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29524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03180F49FFD244E91EA99CBE6D277AD" ma:contentTypeVersion="15" ma:contentTypeDescription="Create a new document." ma:contentTypeScope="" ma:versionID="223722517d6ae3d716df0d7e487f5797">
  <xsd:schema xmlns:xsd="http://www.w3.org/2001/XMLSchema" xmlns:xs="http://www.w3.org/2001/XMLSchema" xmlns:p="http://schemas.microsoft.com/office/2006/metadata/properties" xmlns:ns2="3560b337-db77-4a6d-b284-831057e8378a" xmlns:ns3="15b3688f-8aca-4cd0-b5f9-6b9c69d49994" targetNamespace="http://schemas.microsoft.com/office/2006/metadata/properties" ma:root="true" ma:fieldsID="f35c14efe4c360b57bb716d479a5b5de" ns2:_="" ns3:_="">
    <xsd:import namespace="3560b337-db77-4a6d-b284-831057e8378a"/>
    <xsd:import namespace="15b3688f-8aca-4cd0-b5f9-6b9c69d49994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lcf76f155ced4ddcb4097134ff3c332f" minOccurs="0"/>
                <xsd:element ref="ns2:TaxCatchAll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60b337-db77-4a6d-b284-831057e8378a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e64da8f0-a0c6-4119-84d6-40a675b3a0b6}" ma:internalName="TaxCatchAll" ma:showField="CatchAllData" ma:web="3560b337-db77-4a6d-b284-831057e8378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b3688f-8aca-4cd0-b5f9-6b9c69d4999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3e20e570-3a27-4eff-9ea0-d3488a33fbf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5b3688f-8aca-4cd0-b5f9-6b9c69d49994">
      <Terms xmlns="http://schemas.microsoft.com/office/infopath/2007/PartnerControls"/>
    </lcf76f155ced4ddcb4097134ff3c332f>
    <TaxCatchAll xmlns="3560b337-db77-4a6d-b284-831057e8378a" xsi:nil="true"/>
  </documentManagement>
</p:properties>
</file>

<file path=customXml/itemProps1.xml><?xml version="1.0" encoding="utf-8"?>
<ds:datastoreItem xmlns:ds="http://schemas.openxmlformats.org/officeDocument/2006/customXml" ds:itemID="{3C6934F9-F34C-4ED0-83B2-191AA19580B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EA8F929-6980-4287-B827-EE27B6B6555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560b337-db77-4a6d-b284-831057e8378a"/>
    <ds:schemaRef ds:uri="15b3688f-8aca-4cd0-b5f9-6b9c69d4999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FB5B235-04E5-4328-AF58-BD89DD9EE007}">
  <ds:schemaRefs>
    <ds:schemaRef ds:uri="http://schemas.microsoft.com/office/2006/metadata/properties"/>
    <ds:schemaRef ds:uri="http://schemas.microsoft.com/office/infopath/2007/PartnerControls"/>
    <ds:schemaRef ds:uri="15b3688f-8aca-4cd0-b5f9-6b9c69d49994"/>
    <ds:schemaRef ds:uri="3560b337-db77-4a6d-b284-831057e8378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3</TotalTime>
  <Words>88</Words>
  <Application>Microsoft Office PowerPoint</Application>
  <PresentationFormat>Custom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je Heese</dc:creator>
  <cp:lastModifiedBy>Heese, Antje</cp:lastModifiedBy>
  <cp:revision>47</cp:revision>
  <dcterms:created xsi:type="dcterms:W3CDTF">2022-01-11T17:56:57Z</dcterms:created>
  <dcterms:modified xsi:type="dcterms:W3CDTF">2022-10-11T19:06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03180F49FFD244E91EA99CBE6D277AD</vt:lpwstr>
  </property>
  <property fmtid="{D5CDD505-2E9C-101B-9397-08002B2CF9AE}" pid="3" name="MediaServiceImageTags">
    <vt:lpwstr/>
  </property>
</Properties>
</file>